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89281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等线"/>
                <a:ea typeface="等线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等线"/>
                <a:ea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22280" y="1142640"/>
            <a:ext cx="421344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200" spc="-1" strike="noStrike">
                <a:solidFill>
                  <a:srgbClr val="000000"/>
                </a:solidFill>
                <a:latin typeface="等线"/>
                <a:ea typeface="等线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1B8CEE3-0C67-4485-88B5-EAF36702098D}" type="slidenum">
              <a:rPr b="0" lang="zh-CN" sz="1200" spc="-1" strike="noStrike">
                <a:solidFill>
                  <a:srgbClr val="000000"/>
                </a:solidFill>
                <a:latin typeface="等线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1322280" y="1143000"/>
            <a:ext cx="4213440" cy="308628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等线"/>
              <a:ea typeface="等线"/>
            </a:endParaRPr>
          </a:p>
        </p:txBody>
      </p:sp>
      <p:sp>
        <p:nvSpPr>
          <p:cNvPr id="55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C4211E7-0E87-42F6-A4E0-60228AB413BF}" type="slidenum">
              <a:rPr b="0" lang="zh-CN" sz="1200" spc="-1" strike="noStrike">
                <a:solidFill>
                  <a:srgbClr val="000000"/>
                </a:solidFill>
                <a:latin typeface="等线"/>
                <a:ea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24CEB7-22A4-4263-83EB-E96A045CB61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533556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B932B6-BA98-4B39-B597-ECB2725A3D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2AF82-2DF5-4E44-9531-8A96FFF954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237600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5335560"/>
            <a:ext cx="33858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64DE1-15AD-48B9-A247-80035933BE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301"/>
              </a:spcBef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F66583-933F-4A95-ADE5-92F6368FFB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E8BF58-5714-4CE7-9301-06A53F5EA6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70303-B1D4-45D3-B4A4-179E171314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E94B17-CB7E-4C99-865C-4F6795CB1A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474480"/>
            <a:ext cx="10515600" cy="79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301"/>
              </a:spcBef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73D552-DECD-4596-B894-BAD8A8C69E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96446F-E3EB-4A32-AD64-C47626F810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533556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7BCB4-8829-49A4-9107-F85275A841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2376000"/>
            <a:ext cx="513144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5335560"/>
            <a:ext cx="10515600" cy="2702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301"/>
              </a:spcBef>
              <a:buNone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1B15FB-3299-4F21-B989-97374E3E29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474480"/>
            <a:ext cx="10515600" cy="1725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57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2376000"/>
            <a:ext cx="10515600" cy="5666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9700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1" marL="89208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2" marL="148752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3" marL="2082960" indent="-29700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4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5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  <a:p>
            <a:pPr lvl="6" marL="2678040" indent="-296640">
              <a:lnSpc>
                <a:spcPct val="90000"/>
              </a:lnSpc>
              <a:spcBef>
                <a:spcPts val="1301"/>
              </a:spcBef>
              <a:buClr>
                <a:srgbClr val="000000"/>
              </a:buClr>
              <a:buFont typeface="Arial"/>
              <a:buChar char="•"/>
              <a:tabLst>
                <a:tab algn="l" pos="1189080"/>
                <a:tab algn="l" pos="2378160"/>
                <a:tab algn="l" pos="3567240"/>
                <a:tab algn="l" pos="4756320"/>
                <a:tab algn="l" pos="5945040"/>
                <a:tab algn="l" pos="7134120"/>
                <a:tab algn="l" pos="8323200"/>
                <a:tab algn="l" pos="9512280"/>
                <a:tab algn="l" pos="1070136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8275680"/>
            <a:ext cx="27432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5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15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8275680"/>
            <a:ext cx="41148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8275680"/>
            <a:ext cx="274320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5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5D1784B-01C7-4494-BE1E-DA0859C4FB08}" type="slidenum">
              <a:rPr b="0" lang="zh-CN" sz="15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4" descr=""/>
          <p:cNvPicPr/>
          <p:nvPr/>
        </p:nvPicPr>
        <p:blipFill>
          <a:blip r:embed="rId1"/>
          <a:stretch/>
        </p:blipFill>
        <p:spPr>
          <a:xfrm>
            <a:off x="623880" y="1847880"/>
            <a:ext cx="5315040" cy="3193920"/>
          </a:xfrm>
          <a:prstGeom prst="rect">
            <a:avLst/>
          </a:prstGeom>
          <a:ln w="0">
            <a:noFill/>
          </a:ln>
        </p:spPr>
      </p:pic>
      <p:sp>
        <p:nvSpPr>
          <p:cNvPr id="49" name="文本框 7080"/>
          <p:cNvSpPr/>
          <p:nvPr/>
        </p:nvSpPr>
        <p:spPr>
          <a:xfrm>
            <a:off x="815400" y="5416560"/>
            <a:ext cx="10559160" cy="25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Figure S3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. Comparison of CNA-based pattern and their survival outcome among PMBCL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and three subgroups of DLBCL</a:t>
            </a:r>
            <a:r>
              <a:rPr b="0" lang="zh-CN" sz="2000" spc="-1" strike="noStrike">
                <a:solidFill>
                  <a:srgbClr val="000000"/>
                </a:solidFill>
                <a:latin typeface="Arial"/>
                <a:ea typeface="等线"/>
              </a:rPr>
              <a:t>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(one case of DLBCL with JAK2/PD-L2 amplification and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MYD88 L265P mutation were included in DLBCL_MYD88_L265P group)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a,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Comparison of CNA-based patterns of driver genes among PMBCL and three subgroups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of DLBCL according to the status of JAK2/PD-L2 amplification and MYD88 L265P mutation.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b, 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Survival curves and cox-regression analysis of OS and PFS among three subgroups of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DLBCL after RCHOP-like treatment.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等线"/>
              </a:rPr>
              <a:t> 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图片 2" descr=""/>
          <p:cNvPicPr/>
          <p:nvPr/>
        </p:nvPicPr>
        <p:blipFill>
          <a:blip r:embed="rId2"/>
          <a:stretch/>
        </p:blipFill>
        <p:spPr>
          <a:xfrm>
            <a:off x="6095880" y="1595520"/>
            <a:ext cx="5695920" cy="3591000"/>
          </a:xfrm>
          <a:prstGeom prst="rect">
            <a:avLst/>
          </a:prstGeom>
          <a:ln w="0">
            <a:noFill/>
          </a:ln>
        </p:spPr>
      </p:pic>
      <p:sp>
        <p:nvSpPr>
          <p:cNvPr id="51" name="文本框 39"/>
          <p:cNvSpPr/>
          <p:nvPr/>
        </p:nvSpPr>
        <p:spPr>
          <a:xfrm>
            <a:off x="255600" y="1365120"/>
            <a:ext cx="736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等线"/>
              </a:rPr>
              <a:t>(a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7"/>
          <p:cNvSpPr/>
          <p:nvPr/>
        </p:nvSpPr>
        <p:spPr>
          <a:xfrm>
            <a:off x="5848200" y="1365120"/>
            <a:ext cx="495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等线"/>
              </a:rPr>
              <a:t>(b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3-14T04:27:50Z</dcterms:created>
  <dc:creator>XMX</dc:creator>
  <dc:description/>
  <dc:language>en-US</dc:language>
  <cp:lastModifiedBy>XMX</cp:lastModifiedBy>
  <cp:lastPrinted>2019-03-19T11:17:35Z</cp:lastPrinted>
  <dcterms:modified xsi:type="dcterms:W3CDTF">2020-06-14T14:15:16Z</dcterms:modified>
  <cp:revision>186</cp:revision>
  <dc:subject/>
  <dc:title>PowerPoint 演示文稿</dc:title>
</cp:coreProperties>
</file>